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902" r:id="rId4"/>
    <p:sldId id="882" r:id="rId5"/>
    <p:sldId id="883" r:id="rId6"/>
    <p:sldId id="884" r:id="rId7"/>
    <p:sldId id="885" r:id="rId8"/>
    <p:sldId id="886" r:id="rId9"/>
    <p:sldId id="887" r:id="rId10"/>
    <p:sldId id="888" r:id="rId11"/>
    <p:sldId id="889" r:id="rId12"/>
    <p:sldId id="890" r:id="rId13"/>
    <p:sldId id="891" r:id="rId14"/>
    <p:sldId id="892" r:id="rId15"/>
    <p:sldId id="893" r:id="rId16"/>
    <p:sldId id="895" r:id="rId17"/>
    <p:sldId id="896" r:id="rId18"/>
    <p:sldId id="897" r:id="rId19"/>
    <p:sldId id="898" r:id="rId20"/>
    <p:sldId id="899" r:id="rId21"/>
    <p:sldId id="900" r:id="rId22"/>
    <p:sldId id="901" r:id="rId23"/>
    <p:sldId id="903" r:id="rId24"/>
    <p:sldId id="905" r:id="rId25"/>
    <p:sldId id="906" r:id="rId26"/>
    <p:sldId id="907" r:id="rId27"/>
    <p:sldId id="908" r:id="rId28"/>
    <p:sldId id="909" r:id="rId29"/>
    <p:sldId id="910" r:id="rId30"/>
    <p:sldId id="911" r:id="rId31"/>
    <p:sldId id="912" r:id="rId32"/>
    <p:sldId id="913" r:id="rId33"/>
    <p:sldId id="258" r:id="rId34"/>
    <p:sldId id="914" r:id="rId3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7C10240-D046-4FDF-B9E5-1A208BAD0070}" v="9" dt="2023-09-26T16:50:13.60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132" y="4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tableStyles" Target="tableStyles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viewProps" Target="viewProps.xml"/><Relationship Id="rId40" Type="http://schemas.microsoft.com/office/2016/11/relationships/changesInfo" Target="changesInfos/changesInfo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ghapour, Ehsan" userId="347c9d7f-96de-4b56-a679-037b3172993a" providerId="ADAL" clId="{07C10240-D046-4FDF-B9E5-1A208BAD0070}"/>
    <pc:docChg chg="undo custSel addSld modSld">
      <pc:chgData name="Saghapour, Ehsan" userId="347c9d7f-96de-4b56-a679-037b3172993a" providerId="ADAL" clId="{07C10240-D046-4FDF-B9E5-1A208BAD0070}" dt="2023-09-26T16:50:53.157" v="77" actId="1076"/>
      <pc:docMkLst>
        <pc:docMk/>
      </pc:docMkLst>
      <pc:sldChg chg="addSp modSp add mod">
        <pc:chgData name="Saghapour, Ehsan" userId="347c9d7f-96de-4b56-a679-037b3172993a" providerId="ADAL" clId="{07C10240-D046-4FDF-B9E5-1A208BAD0070}" dt="2023-09-26T14:43:50.231" v="41" actId="1076"/>
        <pc:sldMkLst>
          <pc:docMk/>
          <pc:sldMk cId="705930955" sldId="258"/>
        </pc:sldMkLst>
        <pc:grpChg chg="add mod">
          <ac:chgData name="Saghapour, Ehsan" userId="347c9d7f-96de-4b56-a679-037b3172993a" providerId="ADAL" clId="{07C10240-D046-4FDF-B9E5-1A208BAD0070}" dt="2023-09-26T14:43:45.465" v="37" actId="164"/>
          <ac:grpSpMkLst>
            <pc:docMk/>
            <pc:sldMk cId="705930955" sldId="258"/>
            <ac:grpSpMk id="2" creationId="{5612F66F-BC7A-5B62-F84C-0A2BCC726ABB}"/>
          </ac:grpSpMkLst>
        </pc:grpChg>
        <pc:picChg chg="mod">
          <ac:chgData name="Saghapour, Ehsan" userId="347c9d7f-96de-4b56-a679-037b3172993a" providerId="ADAL" clId="{07C10240-D046-4FDF-B9E5-1A208BAD0070}" dt="2023-09-26T14:43:50.231" v="41" actId="1076"/>
          <ac:picMkLst>
            <pc:docMk/>
            <pc:sldMk cId="705930955" sldId="258"/>
            <ac:picMk id="4" creationId="{39732BBD-90A5-E840-2518-0EF44AF7B82D}"/>
          </ac:picMkLst>
        </pc:picChg>
        <pc:picChg chg="mod">
          <ac:chgData name="Saghapour, Ehsan" userId="347c9d7f-96de-4b56-a679-037b3172993a" providerId="ADAL" clId="{07C10240-D046-4FDF-B9E5-1A208BAD0070}" dt="2023-09-26T14:43:49.830" v="40" actId="1076"/>
          <ac:picMkLst>
            <pc:docMk/>
            <pc:sldMk cId="705930955" sldId="258"/>
            <ac:picMk id="8" creationId="{29FF10EC-DFB2-DA6E-9BCC-1B27BCCBF00C}"/>
          </ac:picMkLst>
        </pc:picChg>
      </pc:sldChg>
      <pc:sldChg chg="addSp delSp modSp new mod setBg">
        <pc:chgData name="Saghapour, Ehsan" userId="347c9d7f-96de-4b56-a679-037b3172993a" providerId="ADAL" clId="{07C10240-D046-4FDF-B9E5-1A208BAD0070}" dt="2023-09-26T16:50:53.157" v="77" actId="1076"/>
        <pc:sldMkLst>
          <pc:docMk/>
          <pc:sldMk cId="1188353034" sldId="912"/>
        </pc:sldMkLst>
        <pc:spChg chg="del mod ord">
          <ac:chgData name="Saghapour, Ehsan" userId="347c9d7f-96de-4b56-a679-037b3172993a" providerId="ADAL" clId="{07C10240-D046-4FDF-B9E5-1A208BAD0070}" dt="2023-09-26T16:50:49.471" v="75" actId="478"/>
          <ac:spMkLst>
            <pc:docMk/>
            <pc:sldMk cId="1188353034" sldId="912"/>
            <ac:spMk id="2" creationId="{0DA66CDE-6425-A6B8-77BB-9337CDE80569}"/>
          </ac:spMkLst>
        </pc:spChg>
        <pc:spChg chg="add del">
          <ac:chgData name="Saghapour, Ehsan" userId="347c9d7f-96de-4b56-a679-037b3172993a" providerId="ADAL" clId="{07C10240-D046-4FDF-B9E5-1A208BAD0070}" dt="2023-09-26T16:50:20.557" v="66" actId="26606"/>
          <ac:spMkLst>
            <pc:docMk/>
            <pc:sldMk cId="1188353034" sldId="912"/>
            <ac:spMk id="8" creationId="{37C89E4B-3C9F-44B9-8B86-D9E3D112D8EC}"/>
          </ac:spMkLst>
        </pc:spChg>
        <pc:spChg chg="add del">
          <ac:chgData name="Saghapour, Ehsan" userId="347c9d7f-96de-4b56-a679-037b3172993a" providerId="ADAL" clId="{07C10240-D046-4FDF-B9E5-1A208BAD0070}" dt="2023-09-26T16:50:45.688" v="74" actId="26606"/>
          <ac:spMkLst>
            <pc:docMk/>
            <pc:sldMk cId="1188353034" sldId="912"/>
            <ac:spMk id="14" creationId="{ECC07320-C2CA-4E29-8481-9D9E143C7788}"/>
          </ac:spMkLst>
        </pc:spChg>
        <pc:picChg chg="add mod">
          <ac:chgData name="Saghapour, Ehsan" userId="347c9d7f-96de-4b56-a679-037b3172993a" providerId="ADAL" clId="{07C10240-D046-4FDF-B9E5-1A208BAD0070}" dt="2023-09-26T16:50:53.157" v="77" actId="1076"/>
          <ac:picMkLst>
            <pc:docMk/>
            <pc:sldMk cId="1188353034" sldId="912"/>
            <ac:picMk id="3" creationId="{DAD7085C-6BE4-0068-7586-3344E7BF0A50}"/>
          </ac:picMkLst>
        </pc:picChg>
        <pc:cxnChg chg="add del">
          <ac:chgData name="Saghapour, Ehsan" userId="347c9d7f-96de-4b56-a679-037b3172993a" providerId="ADAL" clId="{07C10240-D046-4FDF-B9E5-1A208BAD0070}" dt="2023-09-26T16:50:20.557" v="66" actId="26606"/>
          <ac:cxnSpMkLst>
            <pc:docMk/>
            <pc:sldMk cId="1188353034" sldId="912"/>
            <ac:cxnSpMk id="10" creationId="{AA2EAA10-076F-46BD-8F0F-B9A2FB77A85C}"/>
          </ac:cxnSpMkLst>
        </pc:cxnChg>
        <pc:cxnChg chg="add del">
          <ac:chgData name="Saghapour, Ehsan" userId="347c9d7f-96de-4b56-a679-037b3172993a" providerId="ADAL" clId="{07C10240-D046-4FDF-B9E5-1A208BAD0070}" dt="2023-09-26T16:50:20.557" v="66" actId="26606"/>
          <ac:cxnSpMkLst>
            <pc:docMk/>
            <pc:sldMk cId="1188353034" sldId="912"/>
            <ac:cxnSpMk id="12" creationId="{D891E407-403B-4764-86C9-33A56D3BCAA3}"/>
          </ac:cxnSpMkLst>
        </pc:cxnChg>
      </pc:sldChg>
      <pc:sldChg chg="addSp modSp add">
        <pc:chgData name="Saghapour, Ehsan" userId="347c9d7f-96de-4b56-a679-037b3172993a" providerId="ADAL" clId="{07C10240-D046-4FDF-B9E5-1A208BAD0070}" dt="2023-09-26T14:38:37.563" v="2" actId="164"/>
        <pc:sldMkLst>
          <pc:docMk/>
          <pc:sldMk cId="2796469183" sldId="913"/>
        </pc:sldMkLst>
        <pc:grpChg chg="add mod">
          <ac:chgData name="Saghapour, Ehsan" userId="347c9d7f-96de-4b56-a679-037b3172993a" providerId="ADAL" clId="{07C10240-D046-4FDF-B9E5-1A208BAD0070}" dt="2023-09-26T14:38:37.563" v="2" actId="164"/>
          <ac:grpSpMkLst>
            <pc:docMk/>
            <pc:sldMk cId="2796469183" sldId="913"/>
            <ac:grpSpMk id="2" creationId="{A992ABC4-FF31-7BC8-5193-EA294C14C134}"/>
          </ac:grpSpMkLst>
        </pc:grpChg>
        <pc:grpChg chg="mod">
          <ac:chgData name="Saghapour, Ehsan" userId="347c9d7f-96de-4b56-a679-037b3172993a" providerId="ADAL" clId="{07C10240-D046-4FDF-B9E5-1A208BAD0070}" dt="2023-09-26T14:38:37.563" v="2" actId="164"/>
          <ac:grpSpMkLst>
            <pc:docMk/>
            <pc:sldMk cId="2796469183" sldId="913"/>
            <ac:grpSpMk id="47" creationId="{B504A77E-9DF1-F23E-4617-3694A7F1E4C9}"/>
          </ac:grpSpMkLst>
        </pc:grpChg>
        <pc:picChg chg="mod">
          <ac:chgData name="Saghapour, Ehsan" userId="347c9d7f-96de-4b56-a679-037b3172993a" providerId="ADAL" clId="{07C10240-D046-4FDF-B9E5-1A208BAD0070}" dt="2023-09-26T14:38:37.563" v="2" actId="164"/>
          <ac:picMkLst>
            <pc:docMk/>
            <pc:sldMk cId="2796469183" sldId="913"/>
            <ac:picMk id="79" creationId="{60AA9A88-F41F-7B1E-A1F5-49483F52F91B}"/>
          </ac:picMkLst>
        </pc:picChg>
        <pc:picChg chg="mod">
          <ac:chgData name="Saghapour, Ehsan" userId="347c9d7f-96de-4b56-a679-037b3172993a" providerId="ADAL" clId="{07C10240-D046-4FDF-B9E5-1A208BAD0070}" dt="2023-09-26T14:38:37.563" v="2" actId="164"/>
          <ac:picMkLst>
            <pc:docMk/>
            <pc:sldMk cId="2796469183" sldId="913"/>
            <ac:picMk id="81" creationId="{110D720F-4F0B-537E-354D-92B652095338}"/>
          </ac:picMkLst>
        </pc:picChg>
        <pc:picChg chg="mod">
          <ac:chgData name="Saghapour, Ehsan" userId="347c9d7f-96de-4b56-a679-037b3172993a" providerId="ADAL" clId="{07C10240-D046-4FDF-B9E5-1A208BAD0070}" dt="2023-09-26T14:38:37.563" v="2" actId="164"/>
          <ac:picMkLst>
            <pc:docMk/>
            <pc:sldMk cId="2796469183" sldId="913"/>
            <ac:picMk id="82" creationId="{2D365ED6-59D5-DBB7-AD8A-76C390AAF288}"/>
          </ac:picMkLst>
        </pc:picChg>
        <pc:picChg chg="mod">
          <ac:chgData name="Saghapour, Ehsan" userId="347c9d7f-96de-4b56-a679-037b3172993a" providerId="ADAL" clId="{07C10240-D046-4FDF-B9E5-1A208BAD0070}" dt="2023-09-26T14:38:37.563" v="2" actId="164"/>
          <ac:picMkLst>
            <pc:docMk/>
            <pc:sldMk cId="2796469183" sldId="913"/>
            <ac:picMk id="83" creationId="{CE23824D-AAE4-5747-E906-511ED77EA2A9}"/>
          </ac:picMkLst>
        </pc:picChg>
        <pc:picChg chg="mod">
          <ac:chgData name="Saghapour, Ehsan" userId="347c9d7f-96de-4b56-a679-037b3172993a" providerId="ADAL" clId="{07C10240-D046-4FDF-B9E5-1A208BAD0070}" dt="2023-09-26T14:38:37.563" v="2" actId="164"/>
          <ac:picMkLst>
            <pc:docMk/>
            <pc:sldMk cId="2796469183" sldId="913"/>
            <ac:picMk id="87" creationId="{C9DE80B4-0825-144B-8100-D5C51DF82699}"/>
          </ac:picMkLst>
        </pc:picChg>
        <pc:picChg chg="mod">
          <ac:chgData name="Saghapour, Ehsan" userId="347c9d7f-96de-4b56-a679-037b3172993a" providerId="ADAL" clId="{07C10240-D046-4FDF-B9E5-1A208BAD0070}" dt="2023-09-26T14:38:37.563" v="2" actId="164"/>
          <ac:picMkLst>
            <pc:docMk/>
            <pc:sldMk cId="2796469183" sldId="913"/>
            <ac:picMk id="88" creationId="{E2CF492D-2D22-3B5E-96B5-4636BEFCAC02}"/>
          </ac:picMkLst>
        </pc:picChg>
        <pc:picChg chg="mod">
          <ac:chgData name="Saghapour, Ehsan" userId="347c9d7f-96de-4b56-a679-037b3172993a" providerId="ADAL" clId="{07C10240-D046-4FDF-B9E5-1A208BAD0070}" dt="2023-09-26T14:38:37.563" v="2" actId="164"/>
          <ac:picMkLst>
            <pc:docMk/>
            <pc:sldMk cId="2796469183" sldId="913"/>
            <ac:picMk id="89" creationId="{B6B9C6E3-E6D0-D1EC-865F-B85C274C89A1}"/>
          </ac:picMkLst>
        </pc:picChg>
        <pc:picChg chg="mod">
          <ac:chgData name="Saghapour, Ehsan" userId="347c9d7f-96de-4b56-a679-037b3172993a" providerId="ADAL" clId="{07C10240-D046-4FDF-B9E5-1A208BAD0070}" dt="2023-09-26T14:38:37.563" v="2" actId="164"/>
          <ac:picMkLst>
            <pc:docMk/>
            <pc:sldMk cId="2796469183" sldId="913"/>
            <ac:picMk id="90" creationId="{F12813A8-89CB-732A-3E6A-04EC9786512E}"/>
          </ac:picMkLst>
        </pc:picChg>
        <pc:picChg chg="mod">
          <ac:chgData name="Saghapour, Ehsan" userId="347c9d7f-96de-4b56-a679-037b3172993a" providerId="ADAL" clId="{07C10240-D046-4FDF-B9E5-1A208BAD0070}" dt="2023-09-26T14:38:37.563" v="2" actId="164"/>
          <ac:picMkLst>
            <pc:docMk/>
            <pc:sldMk cId="2796469183" sldId="913"/>
            <ac:picMk id="91" creationId="{4EC1C9E7-9E52-1F8B-68A5-4C2A405292EF}"/>
          </ac:picMkLst>
        </pc:picChg>
        <pc:picChg chg="mod">
          <ac:chgData name="Saghapour, Ehsan" userId="347c9d7f-96de-4b56-a679-037b3172993a" providerId="ADAL" clId="{07C10240-D046-4FDF-B9E5-1A208BAD0070}" dt="2023-09-26T14:38:37.563" v="2" actId="164"/>
          <ac:picMkLst>
            <pc:docMk/>
            <pc:sldMk cId="2796469183" sldId="913"/>
            <ac:picMk id="92" creationId="{7C5FBCB1-40ED-683E-01F3-A74ACC76325F}"/>
          </ac:picMkLst>
        </pc:picChg>
        <pc:picChg chg="mod">
          <ac:chgData name="Saghapour, Ehsan" userId="347c9d7f-96de-4b56-a679-037b3172993a" providerId="ADAL" clId="{07C10240-D046-4FDF-B9E5-1A208BAD0070}" dt="2023-09-26T14:38:37.563" v="2" actId="164"/>
          <ac:picMkLst>
            <pc:docMk/>
            <pc:sldMk cId="2796469183" sldId="913"/>
            <ac:picMk id="93" creationId="{392C603D-4397-9F2D-C720-305985C791C8}"/>
          </ac:picMkLst>
        </pc:picChg>
        <pc:picChg chg="mod">
          <ac:chgData name="Saghapour, Ehsan" userId="347c9d7f-96de-4b56-a679-037b3172993a" providerId="ADAL" clId="{07C10240-D046-4FDF-B9E5-1A208BAD0070}" dt="2023-09-26T14:38:37.563" v="2" actId="164"/>
          <ac:picMkLst>
            <pc:docMk/>
            <pc:sldMk cId="2796469183" sldId="913"/>
            <ac:picMk id="94" creationId="{7850221B-416E-3F2E-453D-0012B1DB6B30}"/>
          </ac:picMkLst>
        </pc:picChg>
      </pc:sldChg>
      <pc:sldChg chg="addSp delSp modSp new mod setBg">
        <pc:chgData name="Saghapour, Ehsan" userId="347c9d7f-96de-4b56-a679-037b3172993a" providerId="ADAL" clId="{07C10240-D046-4FDF-B9E5-1A208BAD0070}" dt="2023-09-26T14:44:51.002" v="62" actId="1076"/>
        <pc:sldMkLst>
          <pc:docMk/>
          <pc:sldMk cId="4267472847" sldId="914"/>
        </pc:sldMkLst>
        <pc:spChg chg="del">
          <ac:chgData name="Saghapour, Ehsan" userId="347c9d7f-96de-4b56-a679-037b3172993a" providerId="ADAL" clId="{07C10240-D046-4FDF-B9E5-1A208BAD0070}" dt="2023-09-26T14:41:54.294" v="5" actId="478"/>
          <ac:spMkLst>
            <pc:docMk/>
            <pc:sldMk cId="4267472847" sldId="914"/>
            <ac:spMk id="2" creationId="{3EEEEB81-4050-DD0C-2E5C-71D76B8FFFE2}"/>
          </ac:spMkLst>
        </pc:spChg>
        <pc:spChg chg="del">
          <ac:chgData name="Saghapour, Ehsan" userId="347c9d7f-96de-4b56-a679-037b3172993a" providerId="ADAL" clId="{07C10240-D046-4FDF-B9E5-1A208BAD0070}" dt="2023-09-26T14:41:53.167" v="4" actId="478"/>
          <ac:spMkLst>
            <pc:docMk/>
            <pc:sldMk cId="4267472847" sldId="914"/>
            <ac:spMk id="3" creationId="{DAE64997-0417-3256-4D99-EA3AC29EBA23}"/>
          </ac:spMkLst>
        </pc:spChg>
        <pc:spChg chg="add del">
          <ac:chgData name="Saghapour, Ehsan" userId="347c9d7f-96de-4b56-a679-037b3172993a" providerId="ADAL" clId="{07C10240-D046-4FDF-B9E5-1A208BAD0070}" dt="2023-09-26T14:42:25.705" v="15" actId="26606"/>
          <ac:spMkLst>
            <pc:docMk/>
            <pc:sldMk cId="4267472847" sldId="914"/>
            <ac:spMk id="8" creationId="{F101B3CC-B49F-4CE0-B198-228D1D4285B1}"/>
          </ac:spMkLst>
        </pc:spChg>
        <pc:spChg chg="add del">
          <ac:chgData name="Saghapour, Ehsan" userId="347c9d7f-96de-4b56-a679-037b3172993a" providerId="ADAL" clId="{07C10240-D046-4FDF-B9E5-1A208BAD0070}" dt="2023-09-26T14:42:21.811" v="11" actId="26606"/>
          <ac:spMkLst>
            <pc:docMk/>
            <pc:sldMk cId="4267472847" sldId="914"/>
            <ac:spMk id="11" creationId="{11BE3FA7-0D70-4431-814F-D8C40576EA93}"/>
          </ac:spMkLst>
        </pc:spChg>
        <pc:picChg chg="add del mod ord">
          <ac:chgData name="Saghapour, Ehsan" userId="347c9d7f-96de-4b56-a679-037b3172993a" providerId="ADAL" clId="{07C10240-D046-4FDF-B9E5-1A208BAD0070}" dt="2023-09-26T14:44:29.071" v="56" actId="478"/>
          <ac:picMkLst>
            <pc:docMk/>
            <pc:sldMk cId="4267472847" sldId="914"/>
            <ac:picMk id="5" creationId="{4EA78057-E113-3BF2-0927-5C28A6134756}"/>
          </ac:picMkLst>
        </pc:picChg>
        <pc:picChg chg="add mod">
          <ac:chgData name="Saghapour, Ehsan" userId="347c9d7f-96de-4b56-a679-037b3172993a" providerId="ADAL" clId="{07C10240-D046-4FDF-B9E5-1A208BAD0070}" dt="2023-09-26T14:44:17.327" v="54" actId="14100"/>
          <ac:picMkLst>
            <pc:docMk/>
            <pc:sldMk cId="4267472847" sldId="914"/>
            <ac:picMk id="6" creationId="{E3ADE83E-133B-8C1B-7CCE-8EE16241EE8B}"/>
          </ac:picMkLst>
        </pc:picChg>
        <pc:picChg chg="add del mod">
          <ac:chgData name="Saghapour, Ehsan" userId="347c9d7f-96de-4b56-a679-037b3172993a" providerId="ADAL" clId="{07C10240-D046-4FDF-B9E5-1A208BAD0070}" dt="2023-09-26T14:44:30.335" v="58"/>
          <ac:picMkLst>
            <pc:docMk/>
            <pc:sldMk cId="4267472847" sldId="914"/>
            <ac:picMk id="7" creationId="{7B535BC1-398B-A835-9F9B-32849B5D7192}"/>
          </ac:picMkLst>
        </pc:picChg>
        <pc:picChg chg="add mod">
          <ac:chgData name="Saghapour, Ehsan" userId="347c9d7f-96de-4b56-a679-037b3172993a" providerId="ADAL" clId="{07C10240-D046-4FDF-B9E5-1A208BAD0070}" dt="2023-09-26T14:44:51.002" v="62" actId="1076"/>
          <ac:picMkLst>
            <pc:docMk/>
            <pc:sldMk cId="4267472847" sldId="914"/>
            <ac:picMk id="10" creationId="{E015CB8E-9BC2-5456-70E2-53F88B02467D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902247-0976-8773-A562-6C59ED96100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DACAF75-2F4E-038D-96E0-BE3A19D1DF2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64AD89-7FCA-B219-8F75-67CBE74C53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5F0D3-7302-46D6-B291-EF3A41E91821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C90D54-E4A2-2D8D-635D-31C946780A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84092B-C25B-1C88-BA3C-0690473301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E6D36-7CBD-46D4-80EE-72C679F33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210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7B51BF-796E-C927-8ED4-6C859B2EA7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C681C3F-9354-61DC-9BF7-4B443B6ED0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886F84-E07A-7B23-2D22-AD4D7ED581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5F0D3-7302-46D6-B291-EF3A41E91821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68940D-225B-ED36-B40E-BAF22E4D8C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68F99A-6811-CEB0-073D-4FF6DBD795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E6D36-7CBD-46D4-80EE-72C679F33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9577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636A627-4337-6877-403F-BDDFF231F1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ACDDF5-F212-FFB4-38D7-912A73809D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3F5D67-84DE-7C06-D42D-0222D1F0BA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5F0D3-7302-46D6-B291-EF3A41E91821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2591FD-A7A5-A5A6-7C94-F77262620E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4822D9-1FB2-BA07-3821-B556F4F5F5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E6D36-7CBD-46D4-80EE-72C679F33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1646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485379-69B0-7834-1627-F5C05032C9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A6DF02-D727-F9F6-7BAE-72E5B745628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B1D8A8-E7FA-5297-B235-0A77C8072F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5F0D3-7302-46D6-B291-EF3A41E91821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A674BF-202B-D9DB-810C-F234527C74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3E87D3-EC94-B1E6-B3BF-C1FDA868F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E6D36-7CBD-46D4-80EE-72C679F33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6682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DAF2FA-1258-681E-4185-C560C5ED1F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EB6EA2-2C88-897E-89B3-B642AF84DC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6BAE81-26F9-6A18-D194-025900C065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5F0D3-7302-46D6-B291-EF3A41E91821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7E4D3D-A815-EDB1-3B51-072B63BA7D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C697D0-EF58-28B8-7727-1F7831E657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E6D36-7CBD-46D4-80EE-72C679F33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5400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B6EBD6-5D46-D788-B398-D9D50EAA7F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CE3AF6-A7AF-36A6-C880-816DCDA335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8C5408A-3507-E384-1D8F-221466E3E5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3F5939-1D70-84B1-1C72-63045ECFB2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5F0D3-7302-46D6-B291-EF3A41E91821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3494D0-6410-3D3D-207A-FC5722B593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CE2B18-FDEB-DBAF-DFF8-CE881514C4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E6D36-7CBD-46D4-80EE-72C679F33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07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EBBB36-6717-8137-BA75-60BCB33BD2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353471-0418-60F4-866F-F137C104F1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572699E-3D1C-F317-6E63-244AEA3DE5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41956D5-1760-D22C-137D-1AF4257948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C960D85-3E27-A6EE-2371-8BC896CF0CE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4192A3E-A6C8-4A52-68FE-8056662BB6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5F0D3-7302-46D6-B291-EF3A41E91821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457E38B-6D65-6A8B-5DA4-EEC5CF1E5B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8BB0A34-0961-8493-4EB1-CA16A72BBA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E6D36-7CBD-46D4-80EE-72C679F33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5539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87A780-0E14-9B23-765F-D8C4D28E39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741F1C0-352D-2855-420E-028B8A240E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5F0D3-7302-46D6-B291-EF3A41E91821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A6F6F05-63D3-6A77-49FB-156B076EF9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B5DE5AB-D540-BA5D-E18C-FDD6A1925E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E6D36-7CBD-46D4-80EE-72C679F33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9043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3061AD3-0E59-02BF-0006-629A41B896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5F0D3-7302-46D6-B291-EF3A41E91821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8A87C49-1E7D-B71A-202B-7622B600EC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B884BCD-867C-E188-74A8-1C8AFF0432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E6D36-7CBD-46D4-80EE-72C679F33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8840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3DCB79-9C90-59DC-BEF4-0E3A0B666E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A44488-AB14-DFF7-6CE9-5895DA46E42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DDC425-24AE-ABB9-6F19-BBAF054DD6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C0D91F-3349-C46A-0B00-A181A20DAC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5F0D3-7302-46D6-B291-EF3A41E91821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785512-3D9A-8117-C8D3-E55EE0EE6F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9FCCC3-ACE4-E80E-40BB-85361A3720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E6D36-7CBD-46D4-80EE-72C679F33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58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F7637C-EC58-F203-CC6F-58EDDA80D0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5B1AD12-CC7F-DBF0-D952-F80A050363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86EA70-B10B-EF81-150D-FDBA83CF71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ABFA576-F971-440E-B7FB-56F1F267A2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5F0D3-7302-46D6-B291-EF3A41E91821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1FE1F8-3AD5-E607-0BAC-77EA052B8C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3CD810-B09F-B65F-32D7-C0AAEFFFA6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E6D36-7CBD-46D4-80EE-72C679F33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6874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6FC9FE8-0C99-93E3-9CAD-B5C9F68481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5D82EB-5CA6-2E20-7A78-32F985DF6F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05E607-B892-BF21-DC06-19D127E48D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15F0D3-7302-46D6-B291-EF3A41E91821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45E302-3B13-6B67-A8AF-B808B36B9F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CA88DA-E18D-4744-C98A-A1AE9E9AAAB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DE6D36-7CBD-46D4-80EE-72C679F33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467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6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6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6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6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6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6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6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6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6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6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6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6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6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6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6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6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jpeg"/><Relationship Id="rId1" Type="http://schemas.openxmlformats.org/officeDocument/2006/relationships/slideLayout" Target="../slideLayouts/slideLayout6.xml"/></Relationships>
</file>

<file path=ppt/slides/_rels/slide3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png"/><Relationship Id="rId3" Type="http://schemas.openxmlformats.org/officeDocument/2006/relationships/image" Target="../media/image33.tiff"/><Relationship Id="rId7" Type="http://schemas.openxmlformats.org/officeDocument/2006/relationships/image" Target="../media/image37.tiff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tiff"/><Relationship Id="rId5" Type="http://schemas.openxmlformats.org/officeDocument/2006/relationships/image" Target="../media/image35.tiff"/><Relationship Id="rId4" Type="http://schemas.openxmlformats.org/officeDocument/2006/relationships/image" Target="../media/image34.tiff"/><Relationship Id="rId9" Type="http://schemas.openxmlformats.org/officeDocument/2006/relationships/image" Target="../media/image39.png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1.jpeg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jpg"/><Relationship Id="rId2" Type="http://schemas.openxmlformats.org/officeDocument/2006/relationships/image" Target="../media/image3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3DB360-CED4-0CE3-779E-92E86ECB44EC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ry 2</a:t>
            </a:r>
          </a:p>
        </p:txBody>
      </p:sp>
    </p:spTree>
    <p:extLst>
      <p:ext uri="{BB962C8B-B14F-4D97-AF65-F5344CB8AC3E}">
        <p14:creationId xmlns:p14="http://schemas.microsoft.com/office/powerpoint/2010/main" val="121426110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27F9A5-4201-9843-EE24-A2DD7AD8A8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22872" y="5937789"/>
            <a:ext cx="10515600" cy="428505"/>
          </a:xfrm>
        </p:spPr>
        <p:txBody>
          <a:bodyPr>
            <a:normAutofit/>
          </a:bodyPr>
          <a:lstStyle/>
          <a:p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Figure 8. The Kaplan-Meier plot for STBD1 gen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B9247A9-A771-F049-A2EC-E98593877A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397" y="793630"/>
            <a:ext cx="12192000" cy="50305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82603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B1E0B16-8487-4D0B-7B34-702114CE55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649" y="110425"/>
            <a:ext cx="12192000" cy="5014083"/>
          </a:xfrm>
          <a:prstGeom prst="rect">
            <a:avLst/>
          </a:prstGeom>
        </p:spPr>
      </p:pic>
      <p:sp>
        <p:nvSpPr>
          <p:cNvPr id="6" name="Title 1">
            <a:extLst>
              <a:ext uri="{FF2B5EF4-FFF2-40B4-BE49-F238E27FC236}">
                <a16:creationId xmlns:a16="http://schemas.microsoft.com/office/drawing/2014/main" id="{CD136D4B-29EF-592E-4D0D-E08607D377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704877"/>
            <a:ext cx="10515600" cy="273230"/>
          </a:xfrm>
        </p:spPr>
        <p:txBody>
          <a:bodyPr>
            <a:normAutofit fontScale="90000"/>
          </a:bodyPr>
          <a:lstStyle/>
          <a:p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Figure 9. The Kaplan-Meier plot for KIF5A gene</a:t>
            </a:r>
          </a:p>
        </p:txBody>
      </p:sp>
    </p:spTree>
    <p:extLst>
      <p:ext uri="{BB962C8B-B14F-4D97-AF65-F5344CB8AC3E}">
        <p14:creationId xmlns:p14="http://schemas.microsoft.com/office/powerpoint/2010/main" val="86687859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907379-0D8F-5AE5-D4D6-A8CC2BB7A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69521" y="5825647"/>
            <a:ext cx="10515600" cy="264603"/>
          </a:xfrm>
        </p:spPr>
        <p:txBody>
          <a:bodyPr>
            <a:noAutofit/>
          </a:bodyPr>
          <a:lstStyle/>
          <a:p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Figure 10. The Kaplan-Meier plot for POSTN gen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179F081-56C3-4C4F-A737-BC4C100FDB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858" y="232913"/>
            <a:ext cx="12192000" cy="50821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271997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ADE942-9241-A46B-78E1-9C5592D7D5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51935" y="6153450"/>
            <a:ext cx="10515600" cy="342241"/>
          </a:xfrm>
        </p:spPr>
        <p:txBody>
          <a:bodyPr>
            <a:normAutofit/>
          </a:bodyPr>
          <a:lstStyle/>
          <a:p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Figure 11. The Kaplan-Meier plot for IL1RN gen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1AB1DD4-7AAD-D857-010C-900DB4D573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902" y="534748"/>
            <a:ext cx="12192000" cy="49752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493569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A46414-CBB8-3504-871C-473574066F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13914" y="5886031"/>
            <a:ext cx="10515600" cy="350867"/>
          </a:xfrm>
        </p:spPr>
        <p:txBody>
          <a:bodyPr>
            <a:normAutofit/>
          </a:bodyPr>
          <a:lstStyle/>
          <a:p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Figure 12. The Kaplan-Meier plot for MAPK8IP3 gen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B7D3B67-0D19-EFD7-B303-6E52626B83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071" y="293298"/>
            <a:ext cx="12192000" cy="50528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710523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A5998B2-A13B-944D-AED4-175F8F8F7B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987" y="304487"/>
            <a:ext cx="12192000" cy="4987341"/>
          </a:xfrm>
          <a:prstGeom prst="rect">
            <a:avLst/>
          </a:prstGeom>
        </p:spPr>
      </p:pic>
      <p:sp>
        <p:nvSpPr>
          <p:cNvPr id="3" name="Title 1">
            <a:extLst>
              <a:ext uri="{FF2B5EF4-FFF2-40B4-BE49-F238E27FC236}">
                <a16:creationId xmlns:a16="http://schemas.microsoft.com/office/drawing/2014/main" id="{4D58F8AD-042D-9F0A-5EAA-28E35253CF95}"/>
              </a:ext>
            </a:extLst>
          </p:cNvPr>
          <p:cNvSpPr txBox="1">
            <a:spLocks/>
          </p:cNvSpPr>
          <p:nvPr/>
        </p:nvSpPr>
        <p:spPr>
          <a:xfrm>
            <a:off x="838200" y="5809413"/>
            <a:ext cx="10515600" cy="3508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Figure 13. The Kaplan-Meier plot for ME1 gene</a:t>
            </a:r>
          </a:p>
        </p:txBody>
      </p:sp>
    </p:spTree>
    <p:extLst>
      <p:ext uri="{BB962C8B-B14F-4D97-AF65-F5344CB8AC3E}">
        <p14:creationId xmlns:p14="http://schemas.microsoft.com/office/powerpoint/2010/main" val="47015265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0E1EA69-DF39-F2C9-509C-301E3A5182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277" y="232914"/>
            <a:ext cx="12192000" cy="5059486"/>
          </a:xfrm>
          <a:prstGeom prst="rect">
            <a:avLst/>
          </a:prstGeom>
        </p:spPr>
      </p:pic>
      <p:sp>
        <p:nvSpPr>
          <p:cNvPr id="3" name="Title 1">
            <a:extLst>
              <a:ext uri="{FF2B5EF4-FFF2-40B4-BE49-F238E27FC236}">
                <a16:creationId xmlns:a16="http://schemas.microsoft.com/office/drawing/2014/main" id="{6142A394-7F4E-4774-AD02-A14D96CF735C}"/>
              </a:ext>
            </a:extLst>
          </p:cNvPr>
          <p:cNvSpPr txBox="1">
            <a:spLocks/>
          </p:cNvSpPr>
          <p:nvPr/>
        </p:nvSpPr>
        <p:spPr>
          <a:xfrm>
            <a:off x="1148751" y="6274219"/>
            <a:ext cx="10515600" cy="3508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Figure 14. The Kaplan-Meier plot for APOBEC3C gene</a:t>
            </a:r>
          </a:p>
        </p:txBody>
      </p:sp>
    </p:spTree>
    <p:extLst>
      <p:ext uri="{BB962C8B-B14F-4D97-AF65-F5344CB8AC3E}">
        <p14:creationId xmlns:p14="http://schemas.microsoft.com/office/powerpoint/2010/main" val="230382868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FF92770-E9CF-1EC7-A58C-A8EE997093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3712" y="715992"/>
            <a:ext cx="12192000" cy="5034410"/>
          </a:xfrm>
          <a:prstGeom prst="rect">
            <a:avLst/>
          </a:prstGeom>
        </p:spPr>
      </p:pic>
      <p:sp>
        <p:nvSpPr>
          <p:cNvPr id="3" name="Title 1">
            <a:extLst>
              <a:ext uri="{FF2B5EF4-FFF2-40B4-BE49-F238E27FC236}">
                <a16:creationId xmlns:a16="http://schemas.microsoft.com/office/drawing/2014/main" id="{0315F6A2-18FB-B9E1-540D-B59FC91AB2BB}"/>
              </a:ext>
            </a:extLst>
          </p:cNvPr>
          <p:cNvSpPr txBox="1">
            <a:spLocks/>
          </p:cNvSpPr>
          <p:nvPr/>
        </p:nvSpPr>
        <p:spPr>
          <a:xfrm>
            <a:off x="838200" y="6058559"/>
            <a:ext cx="10515600" cy="3508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Figure 15. The Kaplan-Meier plot for S100A10 gene</a:t>
            </a:r>
          </a:p>
        </p:txBody>
      </p:sp>
    </p:spTree>
    <p:extLst>
      <p:ext uri="{BB962C8B-B14F-4D97-AF65-F5344CB8AC3E}">
        <p14:creationId xmlns:p14="http://schemas.microsoft.com/office/powerpoint/2010/main" val="277987801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AF3FBA8-97DC-6AE5-55EE-F008A13753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586" y="158719"/>
            <a:ext cx="12192000" cy="5091953"/>
          </a:xfrm>
          <a:prstGeom prst="rect">
            <a:avLst/>
          </a:prstGeom>
        </p:spPr>
      </p:pic>
      <p:sp>
        <p:nvSpPr>
          <p:cNvPr id="3" name="Title 1">
            <a:extLst>
              <a:ext uri="{FF2B5EF4-FFF2-40B4-BE49-F238E27FC236}">
                <a16:creationId xmlns:a16="http://schemas.microsoft.com/office/drawing/2014/main" id="{01CF1C3A-DE85-D111-DEF2-2E662F058530}"/>
              </a:ext>
            </a:extLst>
          </p:cNvPr>
          <p:cNvSpPr txBox="1">
            <a:spLocks/>
          </p:cNvSpPr>
          <p:nvPr/>
        </p:nvSpPr>
        <p:spPr>
          <a:xfrm>
            <a:off x="1166004" y="5834272"/>
            <a:ext cx="10515600" cy="3508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Figure 16. The Kaplan-Meier plot for MYCBP gene</a:t>
            </a:r>
          </a:p>
        </p:txBody>
      </p:sp>
    </p:spTree>
    <p:extLst>
      <p:ext uri="{BB962C8B-B14F-4D97-AF65-F5344CB8AC3E}">
        <p14:creationId xmlns:p14="http://schemas.microsoft.com/office/powerpoint/2010/main" val="403351240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7A2140C-6034-7D9C-03BB-F4F3BE51F9C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037" y="284671"/>
            <a:ext cx="12192000" cy="5063166"/>
          </a:xfrm>
          <a:prstGeom prst="rect">
            <a:avLst/>
          </a:prstGeom>
        </p:spPr>
      </p:pic>
      <p:sp>
        <p:nvSpPr>
          <p:cNvPr id="3" name="Title 1">
            <a:extLst>
              <a:ext uri="{FF2B5EF4-FFF2-40B4-BE49-F238E27FC236}">
                <a16:creationId xmlns:a16="http://schemas.microsoft.com/office/drawing/2014/main" id="{2FAEC18D-B1D6-062C-FA97-6032CEF5DEE2}"/>
              </a:ext>
            </a:extLst>
          </p:cNvPr>
          <p:cNvSpPr txBox="1">
            <a:spLocks/>
          </p:cNvSpPr>
          <p:nvPr/>
        </p:nvSpPr>
        <p:spPr>
          <a:xfrm>
            <a:off x="536276" y="5791140"/>
            <a:ext cx="10515600" cy="3508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Figure 17. The Kaplan-Meier plot for LEFTY1 gene</a:t>
            </a:r>
          </a:p>
        </p:txBody>
      </p:sp>
    </p:spTree>
    <p:extLst>
      <p:ext uri="{BB962C8B-B14F-4D97-AF65-F5344CB8AC3E}">
        <p14:creationId xmlns:p14="http://schemas.microsoft.com/office/powerpoint/2010/main" val="28245638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Diagram&#10;&#10;Description automatically generated">
            <a:extLst>
              <a:ext uri="{FF2B5EF4-FFF2-40B4-BE49-F238E27FC236}">
                <a16:creationId xmlns:a16="http://schemas.microsoft.com/office/drawing/2014/main" id="{FAEBF4E7-7688-0D7C-8A7B-6230745FFED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15870" y="2743201"/>
            <a:ext cx="2743200" cy="2743200"/>
          </a:xfrm>
          <a:prstGeom prst="rect">
            <a:avLst/>
          </a:prstGeom>
        </p:spPr>
      </p:pic>
      <p:pic>
        <p:nvPicPr>
          <p:cNvPr id="7" name="Picture 6" descr="Diagram&#10;&#10;Description automatically generated">
            <a:extLst>
              <a:ext uri="{FF2B5EF4-FFF2-40B4-BE49-F238E27FC236}">
                <a16:creationId xmlns:a16="http://schemas.microsoft.com/office/drawing/2014/main" id="{FC01C0F3-C447-9F29-A30F-6D34D4F4DA4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2420" y="2743201"/>
            <a:ext cx="2743200" cy="2743200"/>
          </a:xfrm>
          <a:prstGeom prst="rect">
            <a:avLst/>
          </a:prstGeom>
        </p:spPr>
      </p:pic>
      <p:pic>
        <p:nvPicPr>
          <p:cNvPr id="8" name="Picture 7" descr="A picture containing chart&#10;&#10;Description automatically generated">
            <a:extLst>
              <a:ext uri="{FF2B5EF4-FFF2-40B4-BE49-F238E27FC236}">
                <a16:creationId xmlns:a16="http://schemas.microsoft.com/office/drawing/2014/main" id="{60479EC7-028B-020C-DE37-E53A1C9801B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2420" y="76200"/>
            <a:ext cx="2743200" cy="2743200"/>
          </a:xfrm>
          <a:prstGeom prst="rect">
            <a:avLst/>
          </a:prstGeom>
        </p:spPr>
      </p:pic>
      <p:pic>
        <p:nvPicPr>
          <p:cNvPr id="9" name="Picture 8" descr="Chart&#10;&#10;Description automatically generated">
            <a:extLst>
              <a:ext uri="{FF2B5EF4-FFF2-40B4-BE49-F238E27FC236}">
                <a16:creationId xmlns:a16="http://schemas.microsoft.com/office/drawing/2014/main" id="{B1B0B027-E967-C07C-35B1-9F11A568DA5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1095" y="76200"/>
            <a:ext cx="2743200" cy="27432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A6E5FF37-C6EE-2DF8-9E3D-BD65DCAC1D6C}"/>
              </a:ext>
            </a:extLst>
          </p:cNvPr>
          <p:cNvSpPr txBox="1"/>
          <p:nvPr/>
        </p:nvSpPr>
        <p:spPr>
          <a:xfrm>
            <a:off x="1564432" y="5673012"/>
            <a:ext cx="9063135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Figure1. Showing GTKM profile and their contour for long survival and short survival. A) short survival GTKM, B) long survival GTKM, C) short survival GTKM contour, D) long survival GTKM contour. </a:t>
            </a:r>
            <a:endParaRPr lang="en-US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382C172-3986-188B-40C1-F2F53BC261B3}"/>
              </a:ext>
            </a:extLst>
          </p:cNvPr>
          <p:cNvSpPr txBox="1"/>
          <p:nvPr/>
        </p:nvSpPr>
        <p:spPr>
          <a:xfrm>
            <a:off x="2267456" y="113122"/>
            <a:ext cx="2052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FA39EF3-9DE1-C2C8-2BEB-BDC6ECA2978C}"/>
              </a:ext>
            </a:extLst>
          </p:cNvPr>
          <p:cNvSpPr txBox="1"/>
          <p:nvPr/>
        </p:nvSpPr>
        <p:spPr>
          <a:xfrm>
            <a:off x="5522523" y="76200"/>
            <a:ext cx="2052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165AFCF-50F1-0AA3-1427-93C9FBF93436}"/>
              </a:ext>
            </a:extLst>
          </p:cNvPr>
          <p:cNvSpPr txBox="1"/>
          <p:nvPr/>
        </p:nvSpPr>
        <p:spPr>
          <a:xfrm>
            <a:off x="2266594" y="2708401"/>
            <a:ext cx="2052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8E892DD-744A-BD38-4F56-02FD9DC2A038}"/>
              </a:ext>
            </a:extLst>
          </p:cNvPr>
          <p:cNvSpPr txBox="1"/>
          <p:nvPr/>
        </p:nvSpPr>
        <p:spPr>
          <a:xfrm>
            <a:off x="5605739" y="2743201"/>
            <a:ext cx="1577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67174496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1ADC282-CAD3-73EA-1686-618E84B0B4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047" y="382704"/>
            <a:ext cx="12192000" cy="5056171"/>
          </a:xfrm>
          <a:prstGeom prst="rect">
            <a:avLst/>
          </a:prstGeom>
        </p:spPr>
      </p:pic>
      <p:sp>
        <p:nvSpPr>
          <p:cNvPr id="3" name="Title 1">
            <a:extLst>
              <a:ext uri="{FF2B5EF4-FFF2-40B4-BE49-F238E27FC236}">
                <a16:creationId xmlns:a16="http://schemas.microsoft.com/office/drawing/2014/main" id="{33B99FB2-D2C1-C876-D62B-86DB988BDD98}"/>
              </a:ext>
            </a:extLst>
          </p:cNvPr>
          <p:cNvSpPr txBox="1">
            <a:spLocks/>
          </p:cNvSpPr>
          <p:nvPr/>
        </p:nvSpPr>
        <p:spPr>
          <a:xfrm>
            <a:off x="958970" y="6041306"/>
            <a:ext cx="10515600" cy="3508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Figure 19. The Kaplan-Meier plot for EGR2 gene</a:t>
            </a:r>
          </a:p>
        </p:txBody>
      </p:sp>
    </p:spTree>
    <p:extLst>
      <p:ext uri="{BB962C8B-B14F-4D97-AF65-F5344CB8AC3E}">
        <p14:creationId xmlns:p14="http://schemas.microsoft.com/office/powerpoint/2010/main" val="18998140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D327E03-5EC9-CC9D-C3A2-F03F78B6E8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15992"/>
            <a:ext cx="12192000" cy="5006502"/>
          </a:xfrm>
          <a:prstGeom prst="rect">
            <a:avLst/>
          </a:prstGeom>
        </p:spPr>
      </p:pic>
      <p:sp>
        <p:nvSpPr>
          <p:cNvPr id="3" name="Title 1">
            <a:extLst>
              <a:ext uri="{FF2B5EF4-FFF2-40B4-BE49-F238E27FC236}">
                <a16:creationId xmlns:a16="http://schemas.microsoft.com/office/drawing/2014/main" id="{E5281B63-E5D8-3768-21F2-7BDDB6D3E69F}"/>
              </a:ext>
            </a:extLst>
          </p:cNvPr>
          <p:cNvSpPr txBox="1">
            <a:spLocks/>
          </p:cNvSpPr>
          <p:nvPr/>
        </p:nvSpPr>
        <p:spPr>
          <a:xfrm>
            <a:off x="1045234" y="5966574"/>
            <a:ext cx="10515600" cy="3508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Figure 19. The Kaplan-Meier plot for TGIF1 gene</a:t>
            </a:r>
          </a:p>
        </p:txBody>
      </p:sp>
    </p:spTree>
    <p:extLst>
      <p:ext uri="{BB962C8B-B14F-4D97-AF65-F5344CB8AC3E}">
        <p14:creationId xmlns:p14="http://schemas.microsoft.com/office/powerpoint/2010/main" val="149415170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235A60F-3153-4D49-386C-4227EAB76A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115" y="241539"/>
            <a:ext cx="12192000" cy="5027898"/>
          </a:xfrm>
          <a:prstGeom prst="rect">
            <a:avLst/>
          </a:prstGeom>
        </p:spPr>
      </p:pic>
      <p:sp>
        <p:nvSpPr>
          <p:cNvPr id="3" name="Title 1">
            <a:extLst>
              <a:ext uri="{FF2B5EF4-FFF2-40B4-BE49-F238E27FC236}">
                <a16:creationId xmlns:a16="http://schemas.microsoft.com/office/drawing/2014/main" id="{F0C5CEA5-8FAC-E397-C11C-7D632FA524A8}"/>
              </a:ext>
            </a:extLst>
          </p:cNvPr>
          <p:cNvSpPr txBox="1">
            <a:spLocks/>
          </p:cNvSpPr>
          <p:nvPr/>
        </p:nvSpPr>
        <p:spPr>
          <a:xfrm>
            <a:off x="838200" y="5894657"/>
            <a:ext cx="10515600" cy="3508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Figure 20. The Kaplan-Meier plot for MGP gene</a:t>
            </a:r>
          </a:p>
        </p:txBody>
      </p:sp>
    </p:spTree>
    <p:extLst>
      <p:ext uri="{BB962C8B-B14F-4D97-AF65-F5344CB8AC3E}">
        <p14:creationId xmlns:p14="http://schemas.microsoft.com/office/powerpoint/2010/main" val="3171241203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18B260B5-0BE5-B918-3B75-4D6AAD85F2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469920" y="2766218"/>
            <a:ext cx="2974676" cy="1325563"/>
          </a:xfrm>
        </p:spPr>
        <p:txBody>
          <a:bodyPr>
            <a:normAutofit/>
          </a:bodyPr>
          <a:lstStyle/>
          <a:p>
            <a:r>
              <a:rPr lang="en-US" sz="5400" b="1" dirty="0">
                <a:solidFill>
                  <a:srgbClr val="FF0000"/>
                </a:solidFill>
              </a:rPr>
              <a:t>Region 2</a:t>
            </a:r>
          </a:p>
        </p:txBody>
      </p:sp>
    </p:spTree>
    <p:extLst>
      <p:ext uri="{BB962C8B-B14F-4D97-AF65-F5344CB8AC3E}">
        <p14:creationId xmlns:p14="http://schemas.microsoft.com/office/powerpoint/2010/main" val="2819649411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D7A3BDA-3856-30CF-6175-01ADAB19F0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52887"/>
            <a:ext cx="12192000" cy="505300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8C5ABC5-2D56-5371-E1B3-F2FCFBE6D701}"/>
              </a:ext>
            </a:extLst>
          </p:cNvPr>
          <p:cNvSpPr txBox="1"/>
          <p:nvPr/>
        </p:nvSpPr>
        <p:spPr>
          <a:xfrm>
            <a:off x="517585" y="5737369"/>
            <a:ext cx="61592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Figure 21. The Kaplan-Meier plot for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DOCK2 gene</a:t>
            </a:r>
          </a:p>
        </p:txBody>
      </p:sp>
    </p:spTree>
    <p:extLst>
      <p:ext uri="{BB962C8B-B14F-4D97-AF65-F5344CB8AC3E}">
        <p14:creationId xmlns:p14="http://schemas.microsoft.com/office/powerpoint/2010/main" val="638204378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06BF5DE-5B1D-7777-39E7-3B27FCB45A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3913" y="163813"/>
            <a:ext cx="12192000" cy="501219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5D746AB-C8FD-A7E0-AC88-D0926030226C}"/>
              </a:ext>
            </a:extLst>
          </p:cNvPr>
          <p:cNvSpPr txBox="1"/>
          <p:nvPr/>
        </p:nvSpPr>
        <p:spPr>
          <a:xfrm>
            <a:off x="707366" y="5978908"/>
            <a:ext cx="61592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Figure 22. The Kaplan-Meier plot for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HMOX1 gene</a:t>
            </a:r>
          </a:p>
        </p:txBody>
      </p:sp>
    </p:spTree>
    <p:extLst>
      <p:ext uri="{BB962C8B-B14F-4D97-AF65-F5344CB8AC3E}">
        <p14:creationId xmlns:p14="http://schemas.microsoft.com/office/powerpoint/2010/main" val="509558456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47E1A7F2-4FA6-E176-0644-337FFC41EA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39349"/>
            <a:ext cx="12192000" cy="504406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629E666-FE5E-857C-F185-5C18E27FC21F}"/>
              </a:ext>
            </a:extLst>
          </p:cNvPr>
          <p:cNvSpPr txBox="1"/>
          <p:nvPr/>
        </p:nvSpPr>
        <p:spPr>
          <a:xfrm>
            <a:off x="474452" y="5949319"/>
            <a:ext cx="61592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Figure 23. The Kaplan-Meier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plot for NCF2 </a:t>
            </a:r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gene</a:t>
            </a:r>
          </a:p>
        </p:txBody>
      </p:sp>
    </p:spTree>
    <p:extLst>
      <p:ext uri="{BB962C8B-B14F-4D97-AF65-F5344CB8AC3E}">
        <p14:creationId xmlns:p14="http://schemas.microsoft.com/office/powerpoint/2010/main" val="3557558017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6780073-5EB0-9DCE-A3F2-30FBE83EC6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385" y="845299"/>
            <a:ext cx="12192000" cy="503979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6F6B00C-B803-283C-9A9D-176632E65DE2}"/>
              </a:ext>
            </a:extLst>
          </p:cNvPr>
          <p:cNvSpPr txBox="1"/>
          <p:nvPr/>
        </p:nvSpPr>
        <p:spPr>
          <a:xfrm>
            <a:off x="517585" y="6073798"/>
            <a:ext cx="61592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Figure 24. The Kaplan-Meier plot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for VEGFA gene</a:t>
            </a:r>
          </a:p>
        </p:txBody>
      </p:sp>
    </p:spTree>
    <p:extLst>
      <p:ext uri="{BB962C8B-B14F-4D97-AF65-F5344CB8AC3E}">
        <p14:creationId xmlns:p14="http://schemas.microsoft.com/office/powerpoint/2010/main" val="3147543849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F4BBFEB-6930-6163-B91D-8E974A2C07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5253" y="452887"/>
            <a:ext cx="12192000" cy="496542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3AC36B8-781D-E4A7-4428-E44DEE76402D}"/>
              </a:ext>
            </a:extLst>
          </p:cNvPr>
          <p:cNvSpPr txBox="1"/>
          <p:nvPr/>
        </p:nvSpPr>
        <p:spPr>
          <a:xfrm>
            <a:off x="595222" y="5815006"/>
            <a:ext cx="61592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Figure 25. The Kaplan-Meier plot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for MAPK11 gene</a:t>
            </a:r>
          </a:p>
        </p:txBody>
      </p:sp>
    </p:spTree>
    <p:extLst>
      <p:ext uri="{BB962C8B-B14F-4D97-AF65-F5344CB8AC3E}">
        <p14:creationId xmlns:p14="http://schemas.microsoft.com/office/powerpoint/2010/main" val="2138507096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50FA044-8CFE-5053-BADB-8EB812D168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093" y="1129971"/>
            <a:ext cx="12192000" cy="428155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0E3BE99-108D-5C58-EE63-0A8D8709E17B}"/>
              </a:ext>
            </a:extLst>
          </p:cNvPr>
          <p:cNvSpPr txBox="1"/>
          <p:nvPr/>
        </p:nvSpPr>
        <p:spPr>
          <a:xfrm>
            <a:off x="785004" y="5815006"/>
            <a:ext cx="61592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Figure 26. The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Kaplan-Meier plot for ANXA2 gene</a:t>
            </a:r>
          </a:p>
        </p:txBody>
      </p:sp>
    </p:spTree>
    <p:extLst>
      <p:ext uri="{BB962C8B-B14F-4D97-AF65-F5344CB8AC3E}">
        <p14:creationId xmlns:p14="http://schemas.microsoft.com/office/powerpoint/2010/main" val="9145834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C8D740-FEF9-2C28-EA91-72D26EC20F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469920" y="2766218"/>
            <a:ext cx="2974676" cy="1325563"/>
          </a:xfrm>
        </p:spPr>
        <p:txBody>
          <a:bodyPr>
            <a:normAutofit/>
          </a:bodyPr>
          <a:lstStyle/>
          <a:p>
            <a:r>
              <a:rPr lang="en-US" sz="5400" b="1" dirty="0">
                <a:solidFill>
                  <a:srgbClr val="FF0000"/>
                </a:solidFill>
              </a:rPr>
              <a:t>Region 1</a:t>
            </a:r>
          </a:p>
        </p:txBody>
      </p:sp>
    </p:spTree>
    <p:extLst>
      <p:ext uri="{BB962C8B-B14F-4D97-AF65-F5344CB8AC3E}">
        <p14:creationId xmlns:p14="http://schemas.microsoft.com/office/powerpoint/2010/main" val="2928596499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Graphical user interface, chart, bubble chart&#10;&#10;Description automatically generated">
            <a:extLst>
              <a:ext uri="{FF2B5EF4-FFF2-40B4-BE49-F238E27FC236}">
                <a16:creationId xmlns:a16="http://schemas.microsoft.com/office/drawing/2014/main" id="{E339CC27-312C-BB55-06A2-F3346C39781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36" t="10933" r="13261" b="8081"/>
          <a:stretch/>
        </p:blipFill>
        <p:spPr>
          <a:xfrm>
            <a:off x="2538359" y="645378"/>
            <a:ext cx="5023563" cy="51692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C45175A-B891-6588-1591-8416097876C1}"/>
              </a:ext>
            </a:extLst>
          </p:cNvPr>
          <p:cNvSpPr txBox="1"/>
          <p:nvPr/>
        </p:nvSpPr>
        <p:spPr>
          <a:xfrm>
            <a:off x="1469366" y="6006585"/>
            <a:ext cx="860628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Figure 27. Expanding the number of genes in local short survival GTKM (sigma= 0.01)</a:t>
            </a:r>
          </a:p>
          <a:p>
            <a:endParaRPr lang="en-US" b="1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6654816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alendar&#10;&#10;Description automatically generated">
            <a:extLst>
              <a:ext uri="{FF2B5EF4-FFF2-40B4-BE49-F238E27FC236}">
                <a16:creationId xmlns:a16="http://schemas.microsoft.com/office/drawing/2014/main" id="{DAD7085C-6BE4-0068-7586-3344E7BF0A5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3307"/>
          <a:stretch/>
        </p:blipFill>
        <p:spPr bwMode="auto">
          <a:xfrm>
            <a:off x="839986" y="-379311"/>
            <a:ext cx="10372192" cy="690942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188353034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A992ABC4-FF31-7BC8-5193-EA294C14C134}"/>
              </a:ext>
            </a:extLst>
          </p:cNvPr>
          <p:cNvGrpSpPr/>
          <p:nvPr/>
        </p:nvGrpSpPr>
        <p:grpSpPr>
          <a:xfrm>
            <a:off x="86840" y="36067"/>
            <a:ext cx="11107811" cy="6434505"/>
            <a:chOff x="86840" y="36067"/>
            <a:chExt cx="11107811" cy="6434505"/>
          </a:xfrm>
        </p:grpSpPr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B504A77E-9DF1-F23E-4617-3694A7F1E4C9}"/>
                </a:ext>
              </a:extLst>
            </p:cNvPr>
            <p:cNvGrpSpPr/>
            <p:nvPr/>
          </p:nvGrpSpPr>
          <p:grpSpPr>
            <a:xfrm>
              <a:off x="86840" y="36067"/>
              <a:ext cx="10877736" cy="6434505"/>
              <a:chOff x="86840" y="36067"/>
              <a:chExt cx="10877736" cy="6434505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00A9DEE8-505C-9EC4-0FF0-B3B3782D1D9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423580" y="3589619"/>
                <a:ext cx="2831949" cy="2831949"/>
              </a:xfrm>
              <a:prstGeom prst="rect">
                <a:avLst/>
              </a:prstGeom>
            </p:spPr>
          </p:pic>
          <p:grpSp>
            <p:nvGrpSpPr>
              <p:cNvPr id="32" name="Group 31">
                <a:extLst>
                  <a:ext uri="{FF2B5EF4-FFF2-40B4-BE49-F238E27FC236}">
                    <a16:creationId xmlns:a16="http://schemas.microsoft.com/office/drawing/2014/main" id="{2A06B558-0550-981B-79F5-C4984BA3CBB1}"/>
                  </a:ext>
                </a:extLst>
              </p:cNvPr>
              <p:cNvGrpSpPr/>
              <p:nvPr/>
            </p:nvGrpSpPr>
            <p:grpSpPr>
              <a:xfrm>
                <a:off x="3255529" y="3847731"/>
                <a:ext cx="3138975" cy="2345842"/>
                <a:chOff x="3214887" y="3340158"/>
                <a:chExt cx="3138975" cy="2345842"/>
              </a:xfrm>
            </p:grpSpPr>
            <p:pic>
              <p:nvPicPr>
                <p:cNvPr id="13" name="Picture 12" descr="A close-up of a network&#10;&#10;Description automatically generated">
                  <a:extLst>
                    <a:ext uri="{FF2B5EF4-FFF2-40B4-BE49-F238E27FC236}">
                      <a16:creationId xmlns:a16="http://schemas.microsoft.com/office/drawing/2014/main" id="{EF81F19A-FE7B-9641-1D6B-27AFB3B8662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19573" b="44310"/>
                <a:stretch/>
              </p:blipFill>
              <p:spPr>
                <a:xfrm>
                  <a:off x="3214887" y="3340158"/>
                  <a:ext cx="2941694" cy="2036900"/>
                </a:xfrm>
                <a:prstGeom prst="rect">
                  <a:avLst/>
                </a:prstGeom>
              </p:spPr>
            </p:pic>
            <p:pic>
              <p:nvPicPr>
                <p:cNvPr id="16" name="Picture 15" descr="A close-up of a network&#10;&#10;Description automatically generated">
                  <a:extLst>
                    <a:ext uri="{FF2B5EF4-FFF2-40B4-BE49-F238E27FC236}">
                      <a16:creationId xmlns:a16="http://schemas.microsoft.com/office/drawing/2014/main" id="{A2346711-0BA1-1F42-42A0-D1D1BFA1C25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5546" t="69065" b="9297"/>
                <a:stretch/>
              </p:blipFill>
              <p:spPr>
                <a:xfrm>
                  <a:off x="5093670" y="4894544"/>
                  <a:ext cx="1260192" cy="791456"/>
                </a:xfrm>
                <a:prstGeom prst="rect">
                  <a:avLst/>
                </a:prstGeom>
              </p:spPr>
            </p:pic>
          </p:grpSp>
          <p:grpSp>
            <p:nvGrpSpPr>
              <p:cNvPr id="31" name="Group 30">
                <a:extLst>
                  <a:ext uri="{FF2B5EF4-FFF2-40B4-BE49-F238E27FC236}">
                    <a16:creationId xmlns:a16="http://schemas.microsoft.com/office/drawing/2014/main" id="{54562AD7-FCEC-3FC0-C97D-7B66682C4D31}"/>
                  </a:ext>
                </a:extLst>
              </p:cNvPr>
              <p:cNvGrpSpPr/>
              <p:nvPr/>
            </p:nvGrpSpPr>
            <p:grpSpPr>
              <a:xfrm>
                <a:off x="6973558" y="3287255"/>
                <a:ext cx="3991018" cy="3132779"/>
                <a:chOff x="7097843" y="3032969"/>
                <a:chExt cx="3991018" cy="3132779"/>
              </a:xfrm>
            </p:grpSpPr>
            <p:pic>
              <p:nvPicPr>
                <p:cNvPr id="15" name="Picture 14" descr="A diagram of a network&#10;&#10;Description automatically generated">
                  <a:extLst>
                    <a:ext uri="{FF2B5EF4-FFF2-40B4-BE49-F238E27FC236}">
                      <a16:creationId xmlns:a16="http://schemas.microsoft.com/office/drawing/2014/main" id="{4651A39C-E9E7-0A15-DBD1-14AE1D0CD8C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48852"/>
                <a:stretch/>
              </p:blipFill>
              <p:spPr>
                <a:xfrm>
                  <a:off x="7174042" y="3032969"/>
                  <a:ext cx="3914819" cy="2002337"/>
                </a:xfrm>
                <a:prstGeom prst="rect">
                  <a:avLst/>
                </a:prstGeom>
              </p:spPr>
            </p:pic>
            <p:pic>
              <p:nvPicPr>
                <p:cNvPr id="17" name="Picture 16" descr="A diagram of a network&#10;&#10;Description automatically generated">
                  <a:extLst>
                    <a:ext uri="{FF2B5EF4-FFF2-40B4-BE49-F238E27FC236}">
                      <a16:creationId xmlns:a16="http://schemas.microsoft.com/office/drawing/2014/main" id="{262283B5-2899-3E16-A2C5-E8B7A0433A9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511" t="53656" r="7999" b="7420"/>
                <a:stretch/>
              </p:blipFill>
              <p:spPr>
                <a:xfrm>
                  <a:off x="7097843" y="4403917"/>
                  <a:ext cx="3914819" cy="1761831"/>
                </a:xfrm>
                <a:prstGeom prst="rect">
                  <a:avLst/>
                </a:prstGeom>
              </p:spPr>
            </p:pic>
            <p:pic>
              <p:nvPicPr>
                <p:cNvPr id="19" name="Picture 18" descr="A diagram of a network&#10;&#10;Description automatically generated">
                  <a:extLst>
                    <a:ext uri="{FF2B5EF4-FFF2-40B4-BE49-F238E27FC236}">
                      <a16:creationId xmlns:a16="http://schemas.microsoft.com/office/drawing/2014/main" id="{2089BAFB-2112-E6E5-AA70-8B1FF502F45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0004" t="32257" b="48852"/>
                <a:stretch/>
              </p:blipFill>
              <p:spPr>
                <a:xfrm>
                  <a:off x="10048875" y="4034138"/>
                  <a:ext cx="782811" cy="739557"/>
                </a:xfrm>
                <a:prstGeom prst="rect">
                  <a:avLst/>
                </a:prstGeom>
              </p:spPr>
            </p:pic>
          </p:grpSp>
          <p:pic>
            <p:nvPicPr>
              <p:cNvPr id="21" name="Picture 20" descr="A network diagram with green dots and lines&#10;&#10;Description automatically generated">
                <a:extLst>
                  <a:ext uri="{FF2B5EF4-FFF2-40B4-BE49-F238E27FC236}">
                    <a16:creationId xmlns:a16="http://schemas.microsoft.com/office/drawing/2014/main" id="{A452B89A-0DF8-D583-8D43-2CB5DDDB3D2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97029" y="487302"/>
                <a:ext cx="2831949" cy="2831949"/>
              </a:xfrm>
              <a:prstGeom prst="rect">
                <a:avLst/>
              </a:prstGeom>
            </p:spPr>
          </p:pic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835FB20E-49A1-7512-D0D0-B3F321D01C11}"/>
                  </a:ext>
                </a:extLst>
              </p:cNvPr>
              <p:cNvGrpSpPr/>
              <p:nvPr/>
            </p:nvGrpSpPr>
            <p:grpSpPr>
              <a:xfrm>
                <a:off x="3863981" y="36067"/>
                <a:ext cx="3345709" cy="3115818"/>
                <a:chOff x="2450788" y="1276"/>
                <a:chExt cx="4916469" cy="4378773"/>
              </a:xfrm>
            </p:grpSpPr>
            <p:pic>
              <p:nvPicPr>
                <p:cNvPr id="25" name="Picture 24" descr="A group of green dots and lines&#10;&#10;Description automatically generated">
                  <a:extLst>
                    <a:ext uri="{FF2B5EF4-FFF2-40B4-BE49-F238E27FC236}">
                      <a16:creationId xmlns:a16="http://schemas.microsoft.com/office/drawing/2014/main" id="{48E83535-F80B-FE51-0DAA-2F9E2DABAE5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2486" t="45435" b="37536"/>
                <a:stretch/>
              </p:blipFill>
              <p:spPr>
                <a:xfrm>
                  <a:off x="6096000" y="1543616"/>
                  <a:ext cx="1201094" cy="1167898"/>
                </a:xfrm>
                <a:prstGeom prst="rect">
                  <a:avLst/>
                </a:prstGeom>
              </p:spPr>
            </p:pic>
            <p:pic>
              <p:nvPicPr>
                <p:cNvPr id="27" name="Picture 26" descr="A group of green dots and lines&#10;&#10;Description automatically generated">
                  <a:extLst>
                    <a:ext uri="{FF2B5EF4-FFF2-40B4-BE49-F238E27FC236}">
                      <a16:creationId xmlns:a16="http://schemas.microsoft.com/office/drawing/2014/main" id="{C8F046D6-E809-39B4-1BC4-E7E28F96E2F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0539" r="23025" b="64136"/>
                <a:stretch/>
              </p:blipFill>
              <p:spPr>
                <a:xfrm>
                  <a:off x="3600091" y="1276"/>
                  <a:ext cx="2498756" cy="2459525"/>
                </a:xfrm>
                <a:prstGeom prst="rect">
                  <a:avLst/>
                </a:prstGeom>
              </p:spPr>
            </p:pic>
            <p:pic>
              <p:nvPicPr>
                <p:cNvPr id="28" name="Picture 27" descr="A group of green dots and lines&#10;&#10;Description automatically generated">
                  <a:extLst>
                    <a:ext uri="{FF2B5EF4-FFF2-40B4-BE49-F238E27FC236}">
                      <a16:creationId xmlns:a16="http://schemas.microsoft.com/office/drawing/2014/main" id="{BB1BD1BF-4A23-F376-2665-9364541050B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5743" t="69461" r="24389" b="11397"/>
                <a:stretch/>
              </p:blipFill>
              <p:spPr>
                <a:xfrm>
                  <a:off x="4633110" y="3067297"/>
                  <a:ext cx="2734147" cy="1312752"/>
                </a:xfrm>
                <a:prstGeom prst="rect">
                  <a:avLst/>
                </a:prstGeom>
              </p:spPr>
            </p:pic>
            <p:pic>
              <p:nvPicPr>
                <p:cNvPr id="26" name="Picture 25" descr="A group of green dots and lines&#10;&#10;Description automatically generated">
                  <a:extLst>
                    <a:ext uri="{FF2B5EF4-FFF2-40B4-BE49-F238E27FC236}">
                      <a16:creationId xmlns:a16="http://schemas.microsoft.com/office/drawing/2014/main" id="{3200961E-C6C7-B1C6-4FD2-4D5A14AAD09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722" t="29901" r="65555" b="41716"/>
                <a:stretch/>
              </p:blipFill>
              <p:spPr>
                <a:xfrm>
                  <a:off x="2450788" y="1989924"/>
                  <a:ext cx="1901229" cy="1946495"/>
                </a:xfrm>
                <a:prstGeom prst="rect">
                  <a:avLst/>
                </a:prstGeom>
              </p:spPr>
            </p:pic>
          </p:grpSp>
          <p:pic>
            <p:nvPicPr>
              <p:cNvPr id="30" name="Picture 29" descr="A group of green dots and black text&#10;&#10;Description automatically generated">
                <a:extLst>
                  <a:ext uri="{FF2B5EF4-FFF2-40B4-BE49-F238E27FC236}">
                    <a16:creationId xmlns:a16="http://schemas.microsoft.com/office/drawing/2014/main" id="{FD6F1BE4-067F-9B9F-0089-C740BF42B82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90759" y="313362"/>
                <a:ext cx="2998039" cy="2998039"/>
              </a:xfrm>
              <a:prstGeom prst="rect">
                <a:avLst/>
              </a:prstGeom>
            </p:spPr>
          </p:pic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03C8599D-3E41-16E5-C243-EC3A8F6CD478}"/>
                  </a:ext>
                </a:extLst>
              </p:cNvPr>
              <p:cNvSpPr txBox="1"/>
              <p:nvPr/>
            </p:nvSpPr>
            <p:spPr>
              <a:xfrm>
                <a:off x="86840" y="58447"/>
                <a:ext cx="420377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b="1" dirty="0"/>
                  <a:t>B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32CC8CC1-AB4C-C96B-2817-61865619507E}"/>
                  </a:ext>
                </a:extLst>
              </p:cNvPr>
              <p:cNvSpPr txBox="1"/>
              <p:nvPr/>
            </p:nvSpPr>
            <p:spPr>
              <a:xfrm>
                <a:off x="403488" y="3478399"/>
                <a:ext cx="420377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b="1" dirty="0"/>
                  <a:t>C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5D03EE28-2054-6F81-9614-45634399A6FF}"/>
                  </a:ext>
                </a:extLst>
              </p:cNvPr>
              <p:cNvSpPr txBox="1"/>
              <p:nvPr/>
            </p:nvSpPr>
            <p:spPr>
              <a:xfrm>
                <a:off x="1133627" y="3208843"/>
                <a:ext cx="2385374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Biological Processes</a:t>
                </a:r>
                <a:endParaRPr lang="en-US" sz="1200" b="1" dirty="0"/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AC6F2FB4-EA14-090B-9C53-216BF78F0DE9}"/>
                  </a:ext>
                </a:extLst>
              </p:cNvPr>
              <p:cNvSpPr txBox="1"/>
              <p:nvPr/>
            </p:nvSpPr>
            <p:spPr>
              <a:xfrm>
                <a:off x="988280" y="6140626"/>
                <a:ext cx="2385374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Biological Processes</a:t>
                </a:r>
                <a:endParaRPr lang="en-US" sz="1200" b="1" dirty="0"/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09AFA271-6592-BB25-C34B-87B1525EF02C}"/>
                  </a:ext>
                </a:extLst>
              </p:cNvPr>
              <p:cNvSpPr txBox="1"/>
              <p:nvPr/>
            </p:nvSpPr>
            <p:spPr>
              <a:xfrm>
                <a:off x="4504247" y="3262124"/>
                <a:ext cx="2081144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ea typeface="Calibri" panose="020F0502020204030204" pitchFamily="34" charset="0"/>
                  </a:rPr>
                  <a:t>Cellular Components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6E9918A9-E250-5B5C-8406-607881583658}"/>
                  </a:ext>
                </a:extLst>
              </p:cNvPr>
              <p:cNvSpPr txBox="1"/>
              <p:nvPr/>
            </p:nvSpPr>
            <p:spPr>
              <a:xfrm>
                <a:off x="4504247" y="6193573"/>
                <a:ext cx="2081144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ea typeface="Calibri" panose="020F0502020204030204" pitchFamily="34" charset="0"/>
                  </a:rPr>
                  <a:t>Cellular Components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A4DB58D2-A065-A145-9D25-89D3C41D90AC}"/>
                  </a:ext>
                </a:extLst>
              </p:cNvPr>
              <p:cNvSpPr txBox="1"/>
              <p:nvPr/>
            </p:nvSpPr>
            <p:spPr>
              <a:xfrm>
                <a:off x="8231614" y="3238366"/>
                <a:ext cx="169297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ea typeface="Calibri" panose="020F0502020204030204" pitchFamily="34" charset="0"/>
                  </a:rPr>
                  <a:t>Molecular Functions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86BE28DD-0C4C-C63E-BA90-7177E57A4194}"/>
                  </a:ext>
                </a:extLst>
              </p:cNvPr>
              <p:cNvSpPr txBox="1"/>
              <p:nvPr/>
            </p:nvSpPr>
            <p:spPr>
              <a:xfrm>
                <a:off x="8231614" y="6193572"/>
                <a:ext cx="169297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ea typeface="Calibri" panose="020F0502020204030204" pitchFamily="34" charset="0"/>
                  </a:rPr>
                  <a:t>Molecular Functions</a:t>
                </a:r>
              </a:p>
            </p:txBody>
          </p:sp>
        </p:grpSp>
        <p:pic>
          <p:nvPicPr>
            <p:cNvPr id="79" name="Picture 78">
              <a:extLst>
                <a:ext uri="{FF2B5EF4-FFF2-40B4-BE49-F238E27FC236}">
                  <a16:creationId xmlns:a16="http://schemas.microsoft.com/office/drawing/2014/main" id="{60AA9A88-F41F-7B1E-A1F5-49483F52F91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0195658" y="446851"/>
              <a:ext cx="591889" cy="283947"/>
            </a:xfrm>
            <a:prstGeom prst="rect">
              <a:avLst/>
            </a:prstGeom>
          </p:spPr>
        </p:pic>
        <p:pic>
          <p:nvPicPr>
            <p:cNvPr id="81" name="Picture 80">
              <a:extLst>
                <a:ext uri="{FF2B5EF4-FFF2-40B4-BE49-F238E27FC236}">
                  <a16:creationId xmlns:a16="http://schemas.microsoft.com/office/drawing/2014/main" id="{110D720F-4F0B-537E-354D-92B65209533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588944" y="3563518"/>
              <a:ext cx="591889" cy="283947"/>
            </a:xfrm>
            <a:prstGeom prst="rect">
              <a:avLst/>
            </a:prstGeom>
          </p:spPr>
        </p:pic>
        <p:pic>
          <p:nvPicPr>
            <p:cNvPr id="82" name="Picture 81">
              <a:extLst>
                <a:ext uri="{FF2B5EF4-FFF2-40B4-BE49-F238E27FC236}">
                  <a16:creationId xmlns:a16="http://schemas.microsoft.com/office/drawing/2014/main" id="{2D365ED6-59D5-DBB7-AD8A-76C390AAF28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0195659" y="3575032"/>
              <a:ext cx="591889" cy="283947"/>
            </a:xfrm>
            <a:prstGeom prst="rect">
              <a:avLst/>
            </a:prstGeom>
          </p:spPr>
        </p:pic>
        <p:pic>
          <p:nvPicPr>
            <p:cNvPr id="83" name="Picture 82">
              <a:extLst>
                <a:ext uri="{FF2B5EF4-FFF2-40B4-BE49-F238E27FC236}">
                  <a16:creationId xmlns:a16="http://schemas.microsoft.com/office/drawing/2014/main" id="{CE23824D-AAE4-5747-E906-511ED77EA2A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865549" y="3569208"/>
              <a:ext cx="591889" cy="283947"/>
            </a:xfrm>
            <a:prstGeom prst="rect">
              <a:avLst/>
            </a:prstGeom>
          </p:spPr>
        </p:pic>
        <p:pic>
          <p:nvPicPr>
            <p:cNvPr id="87" name="Picture 86">
              <a:extLst>
                <a:ext uri="{FF2B5EF4-FFF2-40B4-BE49-F238E27FC236}">
                  <a16:creationId xmlns:a16="http://schemas.microsoft.com/office/drawing/2014/main" id="{C9DE80B4-0825-144B-8100-D5C51DF8269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571284" y="3526265"/>
              <a:ext cx="364627" cy="2767611"/>
            </a:xfrm>
            <a:prstGeom prst="rect">
              <a:avLst/>
            </a:prstGeom>
          </p:spPr>
        </p:pic>
        <p:pic>
          <p:nvPicPr>
            <p:cNvPr id="88" name="Picture 87">
              <a:extLst>
                <a:ext uri="{FF2B5EF4-FFF2-40B4-BE49-F238E27FC236}">
                  <a16:creationId xmlns:a16="http://schemas.microsoft.com/office/drawing/2014/main" id="{E2CF492D-2D22-3B5E-96B5-4636BEFCAC0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0830024" y="3503606"/>
              <a:ext cx="364627" cy="2767611"/>
            </a:xfrm>
            <a:prstGeom prst="rect">
              <a:avLst/>
            </a:prstGeom>
          </p:spPr>
        </p:pic>
        <p:pic>
          <p:nvPicPr>
            <p:cNvPr id="89" name="Picture 88">
              <a:extLst>
                <a:ext uri="{FF2B5EF4-FFF2-40B4-BE49-F238E27FC236}">
                  <a16:creationId xmlns:a16="http://schemas.microsoft.com/office/drawing/2014/main" id="{B6B9C6E3-E6D0-D1EC-865F-B85C274C89A1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219878" y="3542934"/>
              <a:ext cx="364627" cy="2767611"/>
            </a:xfrm>
            <a:prstGeom prst="rect">
              <a:avLst/>
            </a:prstGeom>
          </p:spPr>
        </p:pic>
        <p:pic>
          <p:nvPicPr>
            <p:cNvPr id="90" name="Picture 89">
              <a:extLst>
                <a:ext uri="{FF2B5EF4-FFF2-40B4-BE49-F238E27FC236}">
                  <a16:creationId xmlns:a16="http://schemas.microsoft.com/office/drawing/2014/main" id="{F12813A8-89CB-732A-3E6A-04EC9786512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0824008" y="313362"/>
              <a:ext cx="364627" cy="2767611"/>
            </a:xfrm>
            <a:prstGeom prst="rect">
              <a:avLst/>
            </a:prstGeom>
          </p:spPr>
        </p:pic>
        <p:pic>
          <p:nvPicPr>
            <p:cNvPr id="91" name="Picture 90">
              <a:extLst>
                <a:ext uri="{FF2B5EF4-FFF2-40B4-BE49-F238E27FC236}">
                  <a16:creationId xmlns:a16="http://schemas.microsoft.com/office/drawing/2014/main" id="{4EC1C9E7-9E52-1F8B-68A5-4C2A405292E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581340" y="431261"/>
              <a:ext cx="591889" cy="283947"/>
            </a:xfrm>
            <a:prstGeom prst="rect">
              <a:avLst/>
            </a:prstGeom>
          </p:spPr>
        </p:pic>
        <p:pic>
          <p:nvPicPr>
            <p:cNvPr id="92" name="Picture 91">
              <a:extLst>
                <a:ext uri="{FF2B5EF4-FFF2-40B4-BE49-F238E27FC236}">
                  <a16:creationId xmlns:a16="http://schemas.microsoft.com/office/drawing/2014/main" id="{7C5FBCB1-40ED-683E-01F3-A74ACC76325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7209690" y="297772"/>
              <a:ext cx="364627" cy="2767611"/>
            </a:xfrm>
            <a:prstGeom prst="rect">
              <a:avLst/>
            </a:prstGeom>
          </p:spPr>
        </p:pic>
        <p:pic>
          <p:nvPicPr>
            <p:cNvPr id="93" name="Picture 92">
              <a:extLst>
                <a:ext uri="{FF2B5EF4-FFF2-40B4-BE49-F238E27FC236}">
                  <a16:creationId xmlns:a16="http://schemas.microsoft.com/office/drawing/2014/main" id="{392C603D-4397-9F2D-C720-305985C791C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614152" y="483359"/>
              <a:ext cx="591889" cy="283947"/>
            </a:xfrm>
            <a:prstGeom prst="rect">
              <a:avLst/>
            </a:prstGeom>
          </p:spPr>
        </p:pic>
        <p:pic>
          <p:nvPicPr>
            <p:cNvPr id="94" name="Picture 93">
              <a:extLst>
                <a:ext uri="{FF2B5EF4-FFF2-40B4-BE49-F238E27FC236}">
                  <a16:creationId xmlns:a16="http://schemas.microsoft.com/office/drawing/2014/main" id="{7850221B-416E-3F2E-453D-0012B1DB6B30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223576" y="428181"/>
              <a:ext cx="364627" cy="276761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796469183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alendar&#10;&#10;Description automatically generated">
            <a:extLst>
              <a:ext uri="{FF2B5EF4-FFF2-40B4-BE49-F238E27FC236}">
                <a16:creationId xmlns:a16="http://schemas.microsoft.com/office/drawing/2014/main" id="{39732BBD-90A5-E840-2518-0EF44AF7B82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3307"/>
          <a:stretch/>
        </p:blipFill>
        <p:spPr bwMode="auto">
          <a:xfrm>
            <a:off x="2493295" y="-453202"/>
            <a:ext cx="5943600" cy="3959320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29FF10EC-DFB2-DA6E-9BCC-1B27BCCBF00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93294" y="3506118"/>
            <a:ext cx="5943601" cy="31642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5930955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Calendar&#10;&#10;Description automatically generated">
            <a:extLst>
              <a:ext uri="{FF2B5EF4-FFF2-40B4-BE49-F238E27FC236}">
                <a16:creationId xmlns:a16="http://schemas.microsoft.com/office/drawing/2014/main" id="{E3ADE83E-133B-8C1B-7CCE-8EE16241EE8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3307"/>
          <a:stretch/>
        </p:blipFill>
        <p:spPr bwMode="auto">
          <a:xfrm>
            <a:off x="2437256" y="0"/>
            <a:ext cx="6611493" cy="4409402"/>
          </a:xfrm>
          <a:prstGeom prst="rect">
            <a:avLst/>
          </a:prstGeom>
          <a:noFill/>
        </p:spPr>
      </p:pic>
      <p:pic>
        <p:nvPicPr>
          <p:cNvPr id="10" name="Picture 9" descr="A collection of diagrams with green lines&#10;&#10;Description automatically generated with medium confidence">
            <a:extLst>
              <a:ext uri="{FF2B5EF4-FFF2-40B4-BE49-F238E27FC236}">
                <a16:creationId xmlns:a16="http://schemas.microsoft.com/office/drawing/2014/main" id="{E015CB8E-9BC2-5456-70E2-53F88B02467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7637" y="4409402"/>
            <a:ext cx="6611112" cy="38408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74728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13A0A35-6258-1001-D415-F9D1AC41DC2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030"/>
          <a:stretch/>
        </p:blipFill>
        <p:spPr>
          <a:xfrm>
            <a:off x="190706" y="293694"/>
            <a:ext cx="12192000" cy="546557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3D5C58B-86CF-3E61-59DF-98DF895143CD}"/>
              </a:ext>
            </a:extLst>
          </p:cNvPr>
          <p:cNvSpPr txBox="1"/>
          <p:nvPr/>
        </p:nvSpPr>
        <p:spPr>
          <a:xfrm>
            <a:off x="1596006" y="5940976"/>
            <a:ext cx="61628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2. The Kaplan-Meier plot for TNFRSF12A gene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0288589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B253687-428D-DE29-CCEE-2DCCBEF4ED3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467" y="180459"/>
            <a:ext cx="12192000" cy="504005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693604F-6B77-DE5D-5B8D-9E3671572981}"/>
              </a:ext>
            </a:extLst>
          </p:cNvPr>
          <p:cNvSpPr txBox="1"/>
          <p:nvPr/>
        </p:nvSpPr>
        <p:spPr>
          <a:xfrm>
            <a:off x="1263769" y="5851009"/>
            <a:ext cx="621964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ea typeface="Calibri" panose="020F0502020204030204" pitchFamily="34" charset="0"/>
              </a:rPr>
              <a:t>Figure 3. The Kaplan-Meier plot for </a:t>
            </a:r>
            <a:r>
              <a:rPr lang="en-US" b="1" dirty="0"/>
              <a:t>MMP11 gene</a:t>
            </a:r>
          </a:p>
        </p:txBody>
      </p:sp>
    </p:spTree>
    <p:extLst>
      <p:ext uri="{BB962C8B-B14F-4D97-AF65-F5344CB8AC3E}">
        <p14:creationId xmlns:p14="http://schemas.microsoft.com/office/powerpoint/2010/main" val="34315639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3D2BC4-3360-0187-3C4B-1C7605CE28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10172" y="5899547"/>
            <a:ext cx="10515600" cy="394000"/>
          </a:xfrm>
        </p:spPr>
        <p:txBody>
          <a:bodyPr>
            <a:norm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4. The </a:t>
            </a:r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Kaplan-Meier plot for LCP1 gen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7AFA5C0-4725-AA77-EB51-64EAC2E897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240" y="761453"/>
            <a:ext cx="12192000" cy="46272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811938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0A97DF-8A8F-52AD-7360-422BF90A48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69521" y="5809716"/>
            <a:ext cx="10515600" cy="394000"/>
          </a:xfrm>
        </p:spPr>
        <p:txBody>
          <a:bodyPr>
            <a:normAutofit/>
          </a:bodyPr>
          <a:lstStyle/>
          <a:p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Figure 5. The Kaplan-Meier plot for CLIC1 gen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E6F10F7-806A-C8DC-ACA2-CC887569A58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0167" y="309227"/>
            <a:ext cx="12192000" cy="5066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880967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9529D6-774D-FDEE-ECEB-1C907B658C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88365" y="5841848"/>
            <a:ext cx="10515600" cy="445758"/>
          </a:xfrm>
        </p:spPr>
        <p:txBody>
          <a:bodyPr>
            <a:normAutofit/>
          </a:bodyPr>
          <a:lstStyle/>
          <a:p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Figure 6. The Kaplan-Meier plot for SOX4 gen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B594E99-6344-7C12-91C7-5F83824AD7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8987" y="380671"/>
            <a:ext cx="12192000" cy="50902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651748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AA8290-87DB-5AE2-FFF6-82363D97C4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9792" y="6144824"/>
            <a:ext cx="10515600" cy="402626"/>
          </a:xfrm>
        </p:spPr>
        <p:txBody>
          <a:bodyPr>
            <a:normAutofit/>
          </a:bodyPr>
          <a:lstStyle/>
          <a:p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</a:rPr>
              <a:t>Figure 7. The Kaplan-Meier plot for PRRX1 gene</a:t>
            </a:r>
            <a:endParaRPr lang="en-US" sz="18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B433498-1307-EBC2-DEEF-87F8C081718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1449" y="961178"/>
            <a:ext cx="12192000" cy="51176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88391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5</TotalTime>
  <Words>308</Words>
  <Application>Microsoft Office PowerPoint</Application>
  <PresentationFormat>Widescreen</PresentationFormat>
  <Paragraphs>42</Paragraphs>
  <Slides>3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4</vt:i4>
      </vt:variant>
    </vt:vector>
  </HeadingPairs>
  <TitlesOfParts>
    <vt:vector size="38" baseType="lpstr">
      <vt:lpstr>Arial</vt:lpstr>
      <vt:lpstr>Calibri</vt:lpstr>
      <vt:lpstr>Calibri Light</vt:lpstr>
      <vt:lpstr>Office Theme</vt:lpstr>
      <vt:lpstr>Supplementary 2</vt:lpstr>
      <vt:lpstr>PowerPoint Presentation</vt:lpstr>
      <vt:lpstr>Region 1</vt:lpstr>
      <vt:lpstr>PowerPoint Presentation</vt:lpstr>
      <vt:lpstr>PowerPoint Presentation</vt:lpstr>
      <vt:lpstr>Figure 4. The Kaplan-Meier plot for LCP1 gene</vt:lpstr>
      <vt:lpstr>Figure 5. The Kaplan-Meier plot for CLIC1 gene</vt:lpstr>
      <vt:lpstr>Figure 6. The Kaplan-Meier plot for SOX4 gene</vt:lpstr>
      <vt:lpstr>Figure 7. The Kaplan-Meier plot for PRRX1 gene</vt:lpstr>
      <vt:lpstr>Figure 8. The Kaplan-Meier plot for STBD1 gene</vt:lpstr>
      <vt:lpstr>Figure 9. The Kaplan-Meier plot for KIF5A gene</vt:lpstr>
      <vt:lpstr>Figure 10. The Kaplan-Meier plot for POSTN gene</vt:lpstr>
      <vt:lpstr>Figure 11. The Kaplan-Meier plot for IL1RN gene</vt:lpstr>
      <vt:lpstr>Figure 12. The Kaplan-Meier plot for MAPK8IP3 gen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Region 2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2</dc:title>
  <dc:creator>Saghapour, Ehsan</dc:creator>
  <cp:lastModifiedBy>Saghapour, Ehsan</cp:lastModifiedBy>
  <cp:revision>11</cp:revision>
  <dcterms:created xsi:type="dcterms:W3CDTF">2023-03-09T16:28:04Z</dcterms:created>
  <dcterms:modified xsi:type="dcterms:W3CDTF">2023-09-26T16:51:03Z</dcterms:modified>
</cp:coreProperties>
</file>